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3" d="100"/>
          <a:sy n="63" d="100"/>
        </p:scale>
        <p:origin x="170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hl-share.nhlbi.nih.gov\DIRHome\harbisonst\Aim%20I%20Artificial%20Selection\Sleep%20Deprivation%20of%20Populations%20and%20Minos%20Lines\Populations\Sleep%2024%20duration%20plo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hl-share.nhlbi.nih.gov\DIRHome\harbisonst\Aim%20I%20Artificial%20Selection\Sleep%20Deprivation%20of%20Populations%20and%20Minos%20Lines\Populations\Sleep%2024%20duration%20plot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Differences!$F$1</c:f>
              <c:strCache>
                <c:ptCount val="1"/>
                <c:pt idx="0">
                  <c:v>Mean(avgbout24_dep_diff)</c:v>
                </c:pt>
              </c:strCache>
            </c:strRef>
          </c:tx>
          <c:spPr>
            <a:solidFill>
              <a:srgbClr val="666699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Differences!$J$2:$J$5</c:f>
                <c:numCache>
                  <c:formatCode>General</c:formatCode>
                  <c:ptCount val="4"/>
                  <c:pt idx="0">
                    <c:v>1.8750417536999999</c:v>
                  </c:pt>
                  <c:pt idx="1">
                    <c:v>1.7506111282000001</c:v>
                  </c:pt>
                  <c:pt idx="2">
                    <c:v>3.2130848356000001</c:v>
                  </c:pt>
                  <c:pt idx="3">
                    <c:v>2.4676199993000001</c:v>
                  </c:pt>
                </c:numCache>
              </c:numRef>
            </c:plus>
            <c:minus>
              <c:numRef>
                <c:f>Differences!$J$2:$J$5</c:f>
                <c:numCache>
                  <c:formatCode>General</c:formatCode>
                  <c:ptCount val="4"/>
                  <c:pt idx="0">
                    <c:v>1.8750417536999999</c:v>
                  </c:pt>
                  <c:pt idx="1">
                    <c:v>1.7506111282000001</c:v>
                  </c:pt>
                  <c:pt idx="2">
                    <c:v>3.2130848356000001</c:v>
                  </c:pt>
                  <c:pt idx="3">
                    <c:v>2.467619999300000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Differences!$A$2:$A$5</c:f>
              <c:strCache>
                <c:ptCount val="4"/>
                <c:pt idx="0">
                  <c:v>Long R1</c:v>
                </c:pt>
                <c:pt idx="1">
                  <c:v>Short R1</c:v>
                </c:pt>
                <c:pt idx="2">
                  <c:v>Long R2</c:v>
                </c:pt>
                <c:pt idx="3">
                  <c:v>Short R2</c:v>
                </c:pt>
              </c:strCache>
            </c:strRef>
          </c:cat>
          <c:val>
            <c:numRef>
              <c:f>Differences!$F$2:$F$5</c:f>
              <c:numCache>
                <c:formatCode>General</c:formatCode>
                <c:ptCount val="4"/>
                <c:pt idx="0">
                  <c:v>1.1233980300999999</c:v>
                </c:pt>
                <c:pt idx="1">
                  <c:v>1.5622368946</c:v>
                </c:pt>
                <c:pt idx="2">
                  <c:v>6.9716109227</c:v>
                </c:pt>
                <c:pt idx="3">
                  <c:v>3.8125629986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0FD-4B30-9281-9886DA0DDA5E}"/>
            </c:ext>
          </c:extLst>
        </c:ser>
        <c:ser>
          <c:idx val="1"/>
          <c:order val="1"/>
          <c:tx>
            <c:strRef>
              <c:f>Differences!$G$1</c:f>
              <c:strCache>
                <c:ptCount val="1"/>
                <c:pt idx="0">
                  <c:v>Mean(avgbout24_reb_diff)</c:v>
                </c:pt>
              </c:strCache>
            </c:strRef>
          </c:tx>
          <c:spPr>
            <a:solidFill>
              <a:srgbClr val="9999FF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Differences!$K$2:$K$5</c:f>
                <c:numCache>
                  <c:formatCode>General</c:formatCode>
                  <c:ptCount val="4"/>
                  <c:pt idx="0">
                    <c:v>4.2025460099999998</c:v>
                  </c:pt>
                  <c:pt idx="1">
                    <c:v>1.5211995769</c:v>
                  </c:pt>
                  <c:pt idx="2">
                    <c:v>4.3369790816</c:v>
                  </c:pt>
                  <c:pt idx="3">
                    <c:v>1.6204354473</c:v>
                  </c:pt>
                </c:numCache>
              </c:numRef>
            </c:plus>
            <c:minus>
              <c:numRef>
                <c:f>Differences!$K$2:$K$5</c:f>
                <c:numCache>
                  <c:formatCode>General</c:formatCode>
                  <c:ptCount val="4"/>
                  <c:pt idx="0">
                    <c:v>4.2025460099999998</c:v>
                  </c:pt>
                  <c:pt idx="1">
                    <c:v>1.5211995769</c:v>
                  </c:pt>
                  <c:pt idx="2">
                    <c:v>4.3369790816</c:v>
                  </c:pt>
                  <c:pt idx="3">
                    <c:v>1.620435447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Differences!$A$2:$A$5</c:f>
              <c:strCache>
                <c:ptCount val="4"/>
                <c:pt idx="0">
                  <c:v>Long R1</c:v>
                </c:pt>
                <c:pt idx="1">
                  <c:v>Short R1</c:v>
                </c:pt>
                <c:pt idx="2">
                  <c:v>Long R2</c:v>
                </c:pt>
                <c:pt idx="3">
                  <c:v>Short R2</c:v>
                </c:pt>
              </c:strCache>
            </c:strRef>
          </c:cat>
          <c:val>
            <c:numRef>
              <c:f>Differences!$G$2:$G$5</c:f>
              <c:numCache>
                <c:formatCode>General</c:formatCode>
                <c:ptCount val="4"/>
                <c:pt idx="0">
                  <c:v>9.5620676500999995</c:v>
                </c:pt>
                <c:pt idx="1">
                  <c:v>1.3507618775000001</c:v>
                </c:pt>
                <c:pt idx="2">
                  <c:v>16.22172922</c:v>
                </c:pt>
                <c:pt idx="3">
                  <c:v>2.1096763704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0FD-4B30-9281-9886DA0DDA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6940192"/>
        <c:axId val="316947408"/>
      </c:barChart>
      <c:catAx>
        <c:axId val="3169401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6947408"/>
        <c:crosses val="autoZero"/>
        <c:auto val="1"/>
        <c:lblAlgn val="ctr"/>
        <c:lblOffset val="100"/>
        <c:noMultiLvlLbl val="0"/>
      </c:catAx>
      <c:valAx>
        <c:axId val="316947408"/>
        <c:scaling>
          <c:orientation val="minMax"/>
          <c:max val="35"/>
          <c:min val="-2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16940192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Differences!$D$14</c:f>
              <c:strCache>
                <c:ptCount val="1"/>
                <c:pt idx="0">
                  <c:v>Mean(sleepd_reb_dep)</c:v>
                </c:pt>
              </c:strCache>
            </c:strRef>
          </c:tx>
          <c:spPr>
            <a:solidFill>
              <a:srgbClr val="9999FF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Differences!$E$15:$E$18</c:f>
                <c:numCache>
                  <c:formatCode>General</c:formatCode>
                  <c:ptCount val="4"/>
                  <c:pt idx="0">
                    <c:v>11.496396598</c:v>
                  </c:pt>
                  <c:pt idx="1">
                    <c:v>13.516798261</c:v>
                  </c:pt>
                  <c:pt idx="2">
                    <c:v>13.539082828</c:v>
                  </c:pt>
                  <c:pt idx="3">
                    <c:v>9.8445776908999996</c:v>
                  </c:pt>
                </c:numCache>
              </c:numRef>
            </c:plus>
            <c:minus>
              <c:numRef>
                <c:f>Differences!$E$15:$E$18</c:f>
                <c:numCache>
                  <c:formatCode>General</c:formatCode>
                  <c:ptCount val="4"/>
                  <c:pt idx="0">
                    <c:v>11.496396598</c:v>
                  </c:pt>
                  <c:pt idx="1">
                    <c:v>13.516798261</c:v>
                  </c:pt>
                  <c:pt idx="2">
                    <c:v>13.539082828</c:v>
                  </c:pt>
                  <c:pt idx="3">
                    <c:v>9.844577690899999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Differences!$A$15:$A$18</c:f>
              <c:strCache>
                <c:ptCount val="4"/>
                <c:pt idx="0">
                  <c:v>Long R1</c:v>
                </c:pt>
                <c:pt idx="1">
                  <c:v>Short R1</c:v>
                </c:pt>
                <c:pt idx="2">
                  <c:v>Long R2</c:v>
                </c:pt>
                <c:pt idx="3">
                  <c:v>Short R2</c:v>
                </c:pt>
              </c:strCache>
            </c:strRef>
          </c:cat>
          <c:val>
            <c:numRef>
              <c:f>Differences!$D$15:$D$18</c:f>
              <c:numCache>
                <c:formatCode>General</c:formatCode>
                <c:ptCount val="4"/>
                <c:pt idx="0">
                  <c:v>-1.4754098360000001</c:v>
                </c:pt>
                <c:pt idx="1">
                  <c:v>-23.103448279999999</c:v>
                </c:pt>
                <c:pt idx="2">
                  <c:v>-34.991525420000002</c:v>
                </c:pt>
                <c:pt idx="3">
                  <c:v>12.796610168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ADF-4F80-8016-6D7D1C177D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62267416"/>
        <c:axId val="462268072"/>
      </c:barChart>
      <c:catAx>
        <c:axId val="4622674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2268072"/>
        <c:crosses val="autoZero"/>
        <c:auto val="1"/>
        <c:lblAlgn val="ctr"/>
        <c:lblOffset val="100"/>
        <c:noMultiLvlLbl val="0"/>
      </c:catAx>
      <c:valAx>
        <c:axId val="462268072"/>
        <c:scaling>
          <c:orientation val="minMax"/>
          <c:max val="2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22674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6B8F6-7848-4A57-8A7C-4E376085794C}" type="datetimeFigureOut">
              <a:rPr lang="en-US" smtClean="0"/>
              <a:t>10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034B0-C9E4-4B69-9272-265154ECA3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333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6B8F6-7848-4A57-8A7C-4E376085794C}" type="datetimeFigureOut">
              <a:rPr lang="en-US" smtClean="0"/>
              <a:t>10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034B0-C9E4-4B69-9272-265154ECA3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64194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6B8F6-7848-4A57-8A7C-4E376085794C}" type="datetimeFigureOut">
              <a:rPr lang="en-US" smtClean="0"/>
              <a:t>10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034B0-C9E4-4B69-9272-265154ECA3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9019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6B8F6-7848-4A57-8A7C-4E376085794C}" type="datetimeFigureOut">
              <a:rPr lang="en-US" smtClean="0"/>
              <a:t>10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034B0-C9E4-4B69-9272-265154ECA3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9984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6B8F6-7848-4A57-8A7C-4E376085794C}" type="datetimeFigureOut">
              <a:rPr lang="en-US" smtClean="0"/>
              <a:t>10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034B0-C9E4-4B69-9272-265154ECA3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270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6B8F6-7848-4A57-8A7C-4E376085794C}" type="datetimeFigureOut">
              <a:rPr lang="en-US" smtClean="0"/>
              <a:t>10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034B0-C9E4-4B69-9272-265154ECA3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245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6B8F6-7848-4A57-8A7C-4E376085794C}" type="datetimeFigureOut">
              <a:rPr lang="en-US" smtClean="0"/>
              <a:t>10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034B0-C9E4-4B69-9272-265154ECA3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0585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6B8F6-7848-4A57-8A7C-4E376085794C}" type="datetimeFigureOut">
              <a:rPr lang="en-US" smtClean="0"/>
              <a:t>10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034B0-C9E4-4B69-9272-265154ECA3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715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6B8F6-7848-4A57-8A7C-4E376085794C}" type="datetimeFigureOut">
              <a:rPr lang="en-US" smtClean="0"/>
              <a:t>10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034B0-C9E4-4B69-9272-265154ECA3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0946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6B8F6-7848-4A57-8A7C-4E376085794C}" type="datetimeFigureOut">
              <a:rPr lang="en-US" smtClean="0"/>
              <a:t>10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034B0-C9E4-4B69-9272-265154ECA3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460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6B8F6-7848-4A57-8A7C-4E376085794C}" type="datetimeFigureOut">
              <a:rPr lang="en-US" smtClean="0"/>
              <a:t>10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034B0-C9E4-4B69-9272-265154ECA3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49253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26B8F6-7848-4A57-8A7C-4E376085794C}" type="datetimeFigureOut">
              <a:rPr lang="en-US" smtClean="0"/>
              <a:t>10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5034B0-C9E4-4B69-9272-265154ECA3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756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rot="16200000">
            <a:off x="-894220" y="1756487"/>
            <a:ext cx="31772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ifference in 24-hour sleep from baseline (min.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98812" y="4380286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94003" y="13357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-754920" y="6392965"/>
            <a:ext cx="2898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ifference in day sleep from baseline (min.)</a:t>
            </a:r>
          </a:p>
        </p:txBody>
      </p:sp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E3BD5FB3-E3D2-4FFE-8EA5-B6B49A87AD84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3174784029"/>
              </p:ext>
            </p:extLst>
          </p:nvPr>
        </p:nvGraphicFramePr>
        <p:xfrm>
          <a:off x="969264" y="320040"/>
          <a:ext cx="5029200" cy="36460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E12F4B79-8E11-4739-B86E-D299C6E53F42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26783103"/>
              </p:ext>
            </p:extLst>
          </p:nvPr>
        </p:nvGraphicFramePr>
        <p:xfrm>
          <a:off x="969264" y="4846320"/>
          <a:ext cx="5029200" cy="36460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955723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</TotalTime>
  <Words>20</Words>
  <Application>Microsoft Office PowerPoint</Application>
  <PresentationFormat>Letter Paper (8.5x11 in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bison, Susan (NIH/NHLBI) [E]</dc:creator>
  <cp:lastModifiedBy>Harbison, Susan (NIH/NHLBI) [E]</cp:lastModifiedBy>
  <cp:revision>5</cp:revision>
  <dcterms:created xsi:type="dcterms:W3CDTF">2017-10-29T17:03:27Z</dcterms:created>
  <dcterms:modified xsi:type="dcterms:W3CDTF">2017-10-30T17:36:17Z</dcterms:modified>
</cp:coreProperties>
</file>